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0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01" autoAdjust="0"/>
    <p:restoredTop sz="94452" autoAdjust="0"/>
  </p:normalViewPr>
  <p:slideViewPr>
    <p:cSldViewPr snapToGrid="0" showGuides="1">
      <p:cViewPr varScale="1">
        <p:scale>
          <a:sx n="64" d="100"/>
          <a:sy n="64" d="100"/>
        </p:scale>
        <p:origin x="-724" y="-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04E9013-1326-4F5F-90B1-BD0F8AE80141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AF42EEC-254D-4E76-B698-78503C2DD9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45751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C00FE3BB-05FB-4F89-8E92-EE4BB318487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xmlns="" id="{58613EE4-05A6-4061-AA6B-A3561406BA5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FBFB3CE3-B608-4183-A82A-CA0564AB21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4C4CBD74-1AFF-418F-98A2-5C0CAB6A57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491200CD-1927-440D-9702-A58AF3212D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82324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DB821A24-1A19-481D-9BBF-4458EDBB47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B990F8AE-869A-4303-925A-FC2A78677E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86603C43-125D-4BBE-A330-6093F803BC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63006130-BB25-4C4C-BC80-E7FB55D034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9C111ECB-B319-47F4-8580-DD18317B33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13767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xmlns="" id="{12186526-B9E6-4968-AF8C-C5B91AE7CF5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87ACDB55-2E9F-4E82-901E-EBB143E81D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3F7AE7ED-1A51-4181-9AC4-0051B92B30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7AC1CA98-2B82-43B8-BA78-F326ED0FDC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C59A848E-F8EC-4F1E-B6A4-8724F896EE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52024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F19B1E05-5E2D-44EF-8B8C-8EE9E3BF76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C0375FE8-6359-455E-A19D-693DD478BBB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E581665E-CE2F-47DA-AC5F-E91BC94918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9DA39A5F-14D6-404C-A443-66B36B5BD2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1E6F25DE-7443-4C55-AFE7-A3BDCDE5E2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17672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F8A79CB1-6761-4375-AA1B-52005C781B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1AC0114F-C128-4E93-8903-45F76864BF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E7776F77-A9A0-4B18-BE3E-894C32B51A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CA5D3D96-88A8-4C02-A389-FC7A6A299B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B5E2CB97-86CA-4CBD-8BBA-056349E58D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53362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D3735E74-14E4-4559-BD0E-FC1EE6471F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A55D314D-C68B-4152-9506-2B36DA438C6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A20303A9-2F95-4C7E-B6DD-1861B5A8A1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53EF371B-959F-4032-B929-442E54AE5A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A024E8B6-6526-42D0-8C8B-3BE36168C8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211C70F2-4F95-422C-B08A-A476576038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11230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F94A0A87-1273-463C-A9ED-D31A503961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137641B3-FF86-48AD-B0E5-31F7E803A2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F9CE0567-4376-42DA-9D80-815D13E835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xmlns="" id="{A69AD754-91D6-4379-9558-0D40F1050A6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xmlns="" id="{B747143D-AEFB-4D3F-A5B6-85194D6B019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xmlns="" id="{D03949BA-C99F-46F7-83A4-624DD5DEF7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xmlns="" id="{45142078-4104-4D43-9AD8-3CD15F4421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xmlns="" id="{965B79EC-8FBC-43ED-A8E9-1E07E47C73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47871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95A0B6BE-3A32-4016-B8AF-F4ECED92FF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xmlns="" id="{C9AD1B1E-33C5-4EE1-B4EF-9F36C42838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xmlns="" id="{89C6A13A-ED08-493D-94C0-FB1944EA0B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xmlns="" id="{69E9254E-0E6C-4BC6-8B8C-F48BDAEA23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63354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xmlns="" id="{D533A313-5EBB-4EA4-9D77-C99AF5D63F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xmlns="" id="{FFE90A84-0788-4F6F-839B-D4AC5E2605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xmlns="" id="{BFFA6254-85EA-4722-8457-4323B2A1CC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69984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06C4AB64-EEDF-4378-9E5F-A02308CFF9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07BD5F5D-94D1-4B1D-8D7B-F22BBF196D3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F6E7D2EB-E42B-4043-95A4-C5DC6AC39D9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DE43BE18-798F-4AD9-BDB4-EBBF305517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42F1DF57-12E2-4CF2-9054-DE76B20A41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249EE1F0-897D-4095-8E05-0252ABBCC8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69166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5AE757FA-853A-4C60-AD9A-03FB302CFA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xmlns="" id="{F2C9FA4F-5213-4A2C-B374-09BF5E1E800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27A3303A-3EA1-444A-AB82-DEEB9B5F54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9E8D8AF8-7F5D-4447-8A94-588C6B62F7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B91CC48C-2E2A-4424-B690-8C050B9674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5AE6FE8C-6029-4B7D-8421-85C12BDB47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5457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xmlns="" id="{F92B8B03-B21B-4707-A92B-948175F947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29DF6A0B-EBAE-493D-BAA8-6D0D4D2AB8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2E4E0EE6-D4B9-455C-B3BF-7DCFF19EE3B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98047281-BA29-4300-AF39-DB9E95F06A0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42F57D4F-332D-4CEF-A786-B89A5FA7E30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82503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>
            <a:extLst>
              <a:ext uri="{FF2B5EF4-FFF2-40B4-BE49-F238E27FC236}">
                <a16:creationId xmlns:a16="http://schemas.microsoft.com/office/drawing/2014/main" xmlns="" id="{307BC1E3-4694-444F-A204-ED4C10236AF2}"/>
              </a:ext>
            </a:extLst>
          </p:cNvPr>
          <p:cNvSpPr/>
          <p:nvPr/>
        </p:nvSpPr>
        <p:spPr>
          <a:xfrm>
            <a:off x="496229" y="273806"/>
            <a:ext cx="10792047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0 </a:t>
            </a:r>
            <a:r>
              <a:rPr lang="en-US" altLang="zh-CN" sz="1400" b="1" kern="100" dirty="0" smtClean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  Subgroup </a:t>
            </a:r>
            <a:r>
              <a:rPr lang="en-US" altLang="zh-CN" sz="1400" b="1" kern="100" dirty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meta-analysis regarding cerebrospinal fluid Ng levels in patients with </a:t>
            </a:r>
            <a:r>
              <a:rPr lang="en-US" altLang="zh-CN" sz="1400" b="1" kern="100" dirty="0" smtClean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MCI </a:t>
            </a:r>
            <a:r>
              <a:rPr lang="en-US" altLang="zh-CN" sz="1400" b="1" kern="100" dirty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compared with </a:t>
            </a:r>
            <a:r>
              <a:rPr lang="en-US" altLang="zh-CN" sz="1400" b="1" kern="100" dirty="0" smtClean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HC </a:t>
            </a:r>
            <a:r>
              <a:rPr lang="en-US" altLang="zh-CN" sz="1400" b="1" kern="100" dirty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subjects, within ELISA and MSD 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method</a:t>
            </a:r>
            <a:r>
              <a:rPr lang="en-US" altLang="zh-CN" sz="1400" b="1" kern="100" dirty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400" kern="100" dirty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Data includes 2203 individuals from 15 studies. The squares indicate individual study SMD and their corresponding 95% CIs and the sizes of the squares are proportional to study weight. MCI, mild cognitive impairment. HC, healthy controls. CSF, cerebrospinal fluid. SMD, standard mean difference. CI, confidence </a:t>
            </a:r>
            <a:r>
              <a:rPr lang="en-US" altLang="zh-CN" sz="1400" kern="100" dirty="0" smtClean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interval.</a:t>
            </a:r>
            <a:endParaRPr lang="zh-CN" altLang="zh-CN" sz="1100" kern="100" dirty="0"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967A9854-777F-42DB-9741-3F55D65D1589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260" b="3402"/>
          <a:stretch/>
        </p:blipFill>
        <p:spPr>
          <a:xfrm>
            <a:off x="2717820" y="1433418"/>
            <a:ext cx="6756361" cy="53174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580815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03</TotalTime>
  <Words>85</Words>
  <Application>Microsoft Office PowerPoint</Application>
  <PresentationFormat>自定义</PresentationFormat>
  <Paragraphs>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林 华伟</dc:creator>
  <cp:lastModifiedBy>hp</cp:lastModifiedBy>
  <cp:revision>78</cp:revision>
  <dcterms:created xsi:type="dcterms:W3CDTF">2019-09-16T04:07:01Z</dcterms:created>
  <dcterms:modified xsi:type="dcterms:W3CDTF">2020-03-12T13:16:32Z</dcterms:modified>
</cp:coreProperties>
</file>